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C65D06-2C32-469E-B099-1C926818C73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BD39FB-A455-4BF7-8912-6E024EF7FB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497A77-B89F-4EAA-B0BF-553DA155B8D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B53F35-C7CC-401F-9BAB-4C770F925BE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4B7A19-9E38-483B-8ECF-8445450D5B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B2D170-F4A5-4E49-ACC4-A92DD69C14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5B8BD2-3849-4403-914D-A07ECFB112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424C6E-BC03-4149-A5A3-1C09989B00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0B2516-3234-48CD-92D6-CA810F8897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FF767D-D3D9-4E7E-9AC5-E5E7E8D6C8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2D62DE-E083-4813-9B7F-C456AE0D0F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8C5893-7E07-41B6-8016-87276F2FA6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73DD42D-3762-43F1-A6DA-27FDC9B6DED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4"/>
          <p:cNvGrpSpPr/>
          <p:nvPr/>
        </p:nvGrpSpPr>
        <p:grpSpPr>
          <a:xfrm>
            <a:off x="228600" y="1066680"/>
            <a:ext cx="8591400" cy="3353040"/>
            <a:chOff x="228600" y="1066680"/>
            <a:chExt cx="8591400" cy="3353040"/>
          </a:xfrm>
        </p:grpSpPr>
        <p:sp>
          <p:nvSpPr>
            <p:cNvPr id="42" name="Rectangle 11"/>
            <p:cNvSpPr/>
            <p:nvPr/>
          </p:nvSpPr>
          <p:spPr>
            <a:xfrm>
              <a:off x="228600" y="1066680"/>
              <a:ext cx="8591400" cy="3353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43" name="Group 16"/>
            <p:cNvGrpSpPr/>
            <p:nvPr/>
          </p:nvGrpSpPr>
          <p:grpSpPr>
            <a:xfrm>
              <a:off x="333360" y="1171440"/>
              <a:ext cx="8424000" cy="3112200"/>
              <a:chOff x="333360" y="1171440"/>
              <a:chExt cx="8424000" cy="3112200"/>
            </a:xfrm>
          </p:grpSpPr>
          <p:pic>
            <p:nvPicPr>
              <p:cNvPr id="44" name="Picture 2" descr="G:\Institut Pasteur Cambodge 140111\Expé animale\Prélèvements pour histopatho\Slides\IPCC5_2_liver.tif"/>
              <p:cNvPicPr/>
              <p:nvPr/>
            </p:nvPicPr>
            <p:blipFill>
              <a:blip r:embed="rId1"/>
              <a:srcRect l="19689" t="29936" r="18337" b="0"/>
              <a:stretch/>
            </p:blipFill>
            <p:spPr>
              <a:xfrm>
                <a:off x="4618440" y="1171440"/>
                <a:ext cx="4138920" cy="311220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45" name="Group 6"/>
              <p:cNvGrpSpPr/>
              <p:nvPr/>
            </p:nvGrpSpPr>
            <p:grpSpPr>
              <a:xfrm>
                <a:off x="333360" y="1171440"/>
                <a:ext cx="4128480" cy="3112200"/>
                <a:chOff x="333360" y="1171440"/>
                <a:chExt cx="4128480" cy="3112200"/>
              </a:xfrm>
            </p:grpSpPr>
            <p:pic>
              <p:nvPicPr>
                <p:cNvPr id="46" name="Picture 3" descr="G:\Institut Pasteur Cambodge 140111\Expé animale\Prélèvements pour histopatho\Slides\IPCP1_9_lung.tif"/>
                <p:cNvPicPr/>
                <p:nvPr/>
              </p:nvPicPr>
              <p:blipFill>
                <a:blip r:embed="rId2"/>
                <a:srcRect l="18338" t="6673" r="0" b="7776"/>
                <a:stretch/>
              </p:blipFill>
              <p:spPr>
                <a:xfrm>
                  <a:off x="333360" y="1171440"/>
                  <a:ext cx="4128480" cy="3112200"/>
                </a:xfrm>
                <a:prstGeom prst="rect">
                  <a:avLst/>
                </a:prstGeom>
                <a:ln w="0">
                  <a:noFill/>
                </a:ln>
              </p:spPr>
            </p:pic>
            <p:cxnSp>
              <p:nvCxnSpPr>
                <p:cNvPr id="47" name="Straight Arrow Connector 5"/>
                <p:cNvCxnSpPr/>
                <p:nvPr/>
              </p:nvCxnSpPr>
              <p:spPr>
                <a:xfrm flipH="1">
                  <a:off x="3188160" y="2450880"/>
                  <a:ext cx="454680" cy="277200"/>
                </a:xfrm>
                <a:prstGeom prst="straightConnector1">
                  <a:avLst/>
                </a:prstGeom>
                <a:ln w="1908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  <p:cxnSp>
              <p:nvCxnSpPr>
                <p:cNvPr id="48" name="Straight Arrow Connector 8"/>
                <p:cNvCxnSpPr/>
                <p:nvPr/>
              </p:nvCxnSpPr>
              <p:spPr>
                <a:xfrm>
                  <a:off x="3876840" y="2035800"/>
                  <a:ext cx="454680" cy="311760"/>
                </a:xfrm>
                <a:prstGeom prst="straightConnector1">
                  <a:avLst/>
                </a:prstGeom>
                <a:ln w="1908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  <p:cxnSp>
              <p:nvCxnSpPr>
                <p:cNvPr id="49" name="Straight Arrow Connector 9"/>
                <p:cNvCxnSpPr/>
                <p:nvPr/>
              </p:nvCxnSpPr>
              <p:spPr>
                <a:xfrm flipH="1">
                  <a:off x="1571040" y="2935080"/>
                  <a:ext cx="454680" cy="277200"/>
                </a:xfrm>
                <a:prstGeom prst="straightConnector1">
                  <a:avLst/>
                </a:prstGeom>
                <a:ln w="1908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  <p:cxnSp>
              <p:nvCxnSpPr>
                <p:cNvPr id="50" name="Straight Arrow Connector 10"/>
                <p:cNvCxnSpPr/>
                <p:nvPr/>
              </p:nvCxnSpPr>
              <p:spPr>
                <a:xfrm flipH="1">
                  <a:off x="951840" y="1344240"/>
                  <a:ext cx="454680" cy="277200"/>
                </a:xfrm>
                <a:prstGeom prst="straightConnector1">
                  <a:avLst/>
                </a:prstGeom>
                <a:ln w="1908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</p:grpSp>
          <p:sp>
            <p:nvSpPr>
              <p:cNvPr id="51" name="TextBox 12"/>
              <p:cNvSpPr/>
              <p:nvPr/>
            </p:nvSpPr>
            <p:spPr>
              <a:xfrm>
                <a:off x="333360" y="1171440"/>
                <a:ext cx="3135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800" spc="-1" strike="noStrike">
                    <a:solidFill>
                      <a:srgbClr val="000000"/>
                    </a:solidFill>
                    <a:latin typeface="Calibri"/>
                  </a:rPr>
                  <a:t>A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TextBox 13"/>
              <p:cNvSpPr/>
              <p:nvPr/>
            </p:nvSpPr>
            <p:spPr>
              <a:xfrm>
                <a:off x="4618440" y="1171440"/>
                <a:ext cx="3135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53" name="TextBox 17"/>
          <p:cNvSpPr/>
          <p:nvPr/>
        </p:nvSpPr>
        <p:spPr>
          <a:xfrm>
            <a:off x="457200" y="4724280"/>
            <a:ext cx="838188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igure S1: Immunohistochemical analysis for H5N1 virus nucleoprotein detection in merit release birds' organs (experimentally infected)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Immunohistochemical staining of the tissues was carried out for the influenza nucleoprotein detection. A) Lung section: arrows are pointing at few infected cells (red-purple). B) Liver section: numerous influenza-infected cells appear in red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06T08:30:58Z</dcterms:created>
  <dc:creator>Ramona GUTIERREZ</dc:creator>
  <dc:description/>
  <dc:language>en-US</dc:language>
  <cp:lastModifiedBy>Ramona GUTIERREZ</cp:lastModifiedBy>
  <dcterms:modified xsi:type="dcterms:W3CDTF">2011-08-04T10:17:50Z</dcterms:modified>
  <cp:revision>21</cp:revision>
  <dc:subject/>
  <dc:title>Slide 1</dc:title>
</cp:coreProperties>
</file>